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1" d="100"/>
          <a:sy n="81" d="100"/>
        </p:scale>
        <p:origin x="304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97555A-6F60-4FAB-958B-72E5F3CDC7F1}" type="datetimeFigureOut">
              <a:rPr lang="en-AU" smtClean="0"/>
              <a:t>14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459F4D-2F13-4378-92C1-31264A2B41B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108776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97555A-6F60-4FAB-958B-72E5F3CDC7F1}" type="datetimeFigureOut">
              <a:rPr lang="en-AU" smtClean="0"/>
              <a:t>14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459F4D-2F13-4378-92C1-31264A2B41B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686164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97555A-6F60-4FAB-958B-72E5F3CDC7F1}" type="datetimeFigureOut">
              <a:rPr lang="en-AU" smtClean="0"/>
              <a:t>14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459F4D-2F13-4378-92C1-31264A2B41B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634336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97555A-6F60-4FAB-958B-72E5F3CDC7F1}" type="datetimeFigureOut">
              <a:rPr lang="en-AU" smtClean="0"/>
              <a:t>14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459F4D-2F13-4378-92C1-31264A2B41B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786980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97555A-6F60-4FAB-958B-72E5F3CDC7F1}" type="datetimeFigureOut">
              <a:rPr lang="en-AU" smtClean="0"/>
              <a:t>14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459F4D-2F13-4378-92C1-31264A2B41B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757936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97555A-6F60-4FAB-958B-72E5F3CDC7F1}" type="datetimeFigureOut">
              <a:rPr lang="en-AU" smtClean="0"/>
              <a:t>14/10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459F4D-2F13-4378-92C1-31264A2B41B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372520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97555A-6F60-4FAB-958B-72E5F3CDC7F1}" type="datetimeFigureOut">
              <a:rPr lang="en-AU" smtClean="0"/>
              <a:t>14/10/2019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459F4D-2F13-4378-92C1-31264A2B41B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903475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97555A-6F60-4FAB-958B-72E5F3CDC7F1}" type="datetimeFigureOut">
              <a:rPr lang="en-AU" smtClean="0"/>
              <a:t>14/10/2019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459F4D-2F13-4378-92C1-31264A2B41B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29374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97555A-6F60-4FAB-958B-72E5F3CDC7F1}" type="datetimeFigureOut">
              <a:rPr lang="en-AU" smtClean="0"/>
              <a:t>14/10/2019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459F4D-2F13-4378-92C1-31264A2B41B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043816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97555A-6F60-4FAB-958B-72E5F3CDC7F1}" type="datetimeFigureOut">
              <a:rPr lang="en-AU" smtClean="0"/>
              <a:t>14/10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459F4D-2F13-4378-92C1-31264A2B41B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534504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97555A-6F60-4FAB-958B-72E5F3CDC7F1}" type="datetimeFigureOut">
              <a:rPr lang="en-AU" smtClean="0"/>
              <a:t>14/10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459F4D-2F13-4378-92C1-31264A2B41B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003534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97555A-6F60-4FAB-958B-72E5F3CDC7F1}" type="datetimeFigureOut">
              <a:rPr lang="en-AU" smtClean="0"/>
              <a:t>14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459F4D-2F13-4378-92C1-31264A2B41B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67157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Short mKLK14 KLK14019_b_Short mKLK14 KLK14019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6">
            <a:lum/>
          </a:blip>
          <a:srcRect l="7385" t="20185" r="8559" b="20136"/>
          <a:stretch/>
        </p:blipFill>
        <p:spPr>
          <a:xfrm>
            <a:off x="419100" y="-1"/>
            <a:ext cx="5920740" cy="4203701"/>
          </a:xfrm>
          <a:prstGeom prst="rect">
            <a:avLst/>
          </a:prstGeom>
        </p:spPr>
      </p:pic>
      <p:cxnSp>
        <p:nvCxnSpPr>
          <p:cNvPr id="8" name="Straight Connector 7"/>
          <p:cNvCxnSpPr/>
          <p:nvPr/>
        </p:nvCxnSpPr>
        <p:spPr>
          <a:xfrm>
            <a:off x="419100" y="4273735"/>
            <a:ext cx="5905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419100" y="4273735"/>
            <a:ext cx="6096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µm</a:t>
            </a:r>
            <a:endParaRPr lang="en-AU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19100" y="9356735"/>
            <a:ext cx="59207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Supp </a:t>
            </a:r>
            <a:r>
              <a:rPr lang="en-AU" sz="12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Movies :</a:t>
            </a:r>
            <a:r>
              <a:rPr lang="en-AU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AU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ive cell imaging of LNCaP KLK14-GFP cells. Acquisition every 4 min over a period of 3 hours. (Green: KLK14-GFP; Grey: cell tracker; Blue: Nucleus) 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Short mKLK14 KLK14019_e_Short mKLK14 KLK14019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7">
            <a:lum/>
          </a:blip>
          <a:srcRect l="9809" t="17787" r="23066" b="12089"/>
          <a:stretch/>
        </p:blipFill>
        <p:spPr>
          <a:xfrm>
            <a:off x="1192728" y="4531049"/>
            <a:ext cx="4562475" cy="4766311"/>
          </a:xfrm>
          <a:prstGeom prst="rect">
            <a:avLst/>
          </a:prstGeom>
        </p:spPr>
      </p:pic>
      <p:cxnSp>
        <p:nvCxnSpPr>
          <p:cNvPr id="11" name="Straight Connector 10"/>
          <p:cNvCxnSpPr/>
          <p:nvPr/>
        </p:nvCxnSpPr>
        <p:spPr>
          <a:xfrm>
            <a:off x="1268928" y="8977320"/>
            <a:ext cx="59055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1268928" y="8977320"/>
            <a:ext cx="6096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9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µm</a:t>
            </a:r>
            <a:endParaRPr lang="en-AU" sz="9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186669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38</Words>
  <Application>Microsoft Office PowerPoint</Application>
  <PresentationFormat>A4 Paper (210x297 mm)</PresentationFormat>
  <Paragraphs>3</Paragraphs>
  <Slides>1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omas Kryza</dc:creator>
  <cp:lastModifiedBy>Thomas Kryza</cp:lastModifiedBy>
  <cp:revision>3</cp:revision>
  <dcterms:created xsi:type="dcterms:W3CDTF">2019-09-03T01:51:53Z</dcterms:created>
  <dcterms:modified xsi:type="dcterms:W3CDTF">2019-10-14T02:38:00Z</dcterms:modified>
</cp:coreProperties>
</file>